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16" autoAdjust="0"/>
    <p:restoredTop sz="94660"/>
  </p:normalViewPr>
  <p:slideViewPr>
    <p:cSldViewPr snapToGrid="0">
      <p:cViewPr varScale="1">
        <p:scale>
          <a:sx n="59" d="100"/>
          <a:sy n="59" d="100"/>
        </p:scale>
        <p:origin x="98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B63D68-862F-92F9-651E-D2CB7DF41C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F9702A0-D4D3-1BA9-0664-08FBE56C17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F973D3-24EB-A840-1C53-604D77FCA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32894E-39ED-982F-3842-5D16D3185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9D9487-3A4D-3BAE-FF4F-2AF031E79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6284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363B37-1DE2-3676-CDB3-C95A5C62F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2CCABB2-F140-0AAF-F04D-DC4F80B3C7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A4C186-FB10-6298-152C-AAA2D54B7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C56040-99E7-2832-1FE9-C9E52CECF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CCB781-A462-D625-F141-A8EE705BE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55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C8973F7-4BB3-1F3E-F2CC-D13C1BBDBC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5901A8A-C440-F507-48FA-8D21042660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734522-1C9B-26EF-6BCF-665B29883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3AF6F5-D190-4077-8115-3E79A7CAC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D9AAFA8-176D-B1C3-8EAF-4014E63F8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7221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BF2928-1151-4BE8-8FEA-E283E68DD6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2166EC-6B20-B0F4-36D5-1494602828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1370EE-999B-20FF-0F23-D4ED33B1F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B83740-B565-5DE3-01F5-50A4EB52D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E72527-5079-D8C5-4797-77F6571E9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2217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619E5B-73BE-5A45-0C86-761DCAD3CF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6E4E3F-69DC-9EAD-6155-12ED452AFE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E9006E-9F89-E1B4-8451-CFC213DDB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870CD6-34B0-D519-0D65-94566E95F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050A4E-A933-69D7-B520-AFB2D3696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1888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8B2983-0B38-DD66-1299-5740D27CA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2ABA627-0271-DE13-C0F7-9F8AC989B8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F8205B-2965-8EB1-F403-14E387E948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397333-349C-C3E3-9430-15DB9D4EC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87B3F2-6570-5AA6-2C86-FE1EE12E1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A47B736-637A-D9F0-9433-FB5E8DA14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327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5F1E11-D99E-70D6-AFDC-DCE57E344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B320307-917B-7CF3-AD88-E65E2FE5FF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007C35B-8D13-62A6-70CE-7E318FE925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08E2BAB-BDC7-0E06-FEA1-1BEE1C2E1B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A056C12-DD71-6463-89EC-A6725CD821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EE0062E-2B83-C344-6273-D197DF8C4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9896882-74E5-B7D6-D596-F8B26FFA0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42A57EC-3049-B124-E2FF-F91C46385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446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F8B1DF0-45A7-470E-7606-69DDBADC8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7457F41-5FB7-4934-E882-32848E373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E25AB80-1C07-D797-4DDB-CDD906CCF0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F890926-5BF2-5D94-6878-4AE93D526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0665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BF4DDF5-E7BC-C8F8-1F43-A6F630390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3992B1A-706A-8864-2B40-6853D0E10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739E599-3EE1-CED8-5AF5-F62F82403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437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97340D-3BB1-36A5-FDD9-178DF9285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E0626B-A320-7D3B-4C35-2F9D277B8B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BE5BBDE-51C1-10A1-96F7-7D60822A85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50C7293-A39D-66CA-D871-CEBE1C649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1AF506-379F-E9B3-59E5-46DA271F3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CE19B3E-EE8B-DE34-5C5D-D59D7BDEA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73455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87DA95-720E-5817-97BB-97B0950BA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F22ACD5-7B70-462F-D704-45DA12A0E2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7A3B92F-742F-75FA-7F7E-FCBE256DA8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3F87FA-6C72-69B3-619F-A1F83AE6A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2B9A94-C424-0395-46C9-ED0A47130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8AA99C-23E4-1DF9-6EBF-1B5E96A3C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892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303A7A5-AF15-C739-B238-48D401F56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49BD29-3829-68C6-B405-F51F07FE03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A5FD3E-9C69-4812-88B6-9506D5E3AA9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D0A936-EA3C-41A8-8C5B-02C085A26368}" type="datetimeFigureOut">
              <a:rPr lang="zh-CN" altLang="en-US" smtClean="0"/>
              <a:t>2025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3DD319-1BAA-9086-4F77-3E0E4194A5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D8A2B0-51A7-69BE-E246-31B31CF5AF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1817E3-DA58-47DD-BE90-206E4986F4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341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表格 10">
            <a:extLst>
              <a:ext uri="{FF2B5EF4-FFF2-40B4-BE49-F238E27FC236}">
                <a16:creationId xmlns:a16="http://schemas.microsoft.com/office/drawing/2014/main" id="{EB382AEA-F554-8D97-52A4-4E6DE622C6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3179180"/>
              </p:ext>
            </p:extLst>
          </p:nvPr>
        </p:nvGraphicFramePr>
        <p:xfrm>
          <a:off x="1400060" y="397394"/>
          <a:ext cx="3714199" cy="63733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0475">
                  <a:extLst>
                    <a:ext uri="{9D8B030D-6E8A-4147-A177-3AD203B41FA5}">
                      <a16:colId xmlns:a16="http://schemas.microsoft.com/office/drawing/2014/main" val="173795512"/>
                    </a:ext>
                  </a:extLst>
                </a:gridCol>
                <a:gridCol w="1226862">
                  <a:extLst>
                    <a:ext uri="{9D8B030D-6E8A-4147-A177-3AD203B41FA5}">
                      <a16:colId xmlns:a16="http://schemas.microsoft.com/office/drawing/2014/main" val="4271489778"/>
                    </a:ext>
                  </a:extLst>
                </a:gridCol>
                <a:gridCol w="1226862">
                  <a:extLst>
                    <a:ext uri="{9D8B030D-6E8A-4147-A177-3AD203B41FA5}">
                      <a16:colId xmlns:a16="http://schemas.microsoft.com/office/drawing/2014/main" val="2603861470"/>
                    </a:ext>
                  </a:extLst>
                </a:gridCol>
              </a:tblGrid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Bank No.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ing Dat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9100331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1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2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798116451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1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2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215206851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2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3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086121588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2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3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588325119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5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397797550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5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2908963159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6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6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529398674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6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22479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4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6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7/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821872934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5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8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733259127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5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6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9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239735965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69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1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995945592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6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1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97493676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1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772242122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7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2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235726250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7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2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862562071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7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2/1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67300980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7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2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808305075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7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6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2500548126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7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2305418289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8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6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796491046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8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2/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31116850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8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3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063350406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8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3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294838877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8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3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993839188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8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3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49740378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9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4/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202597813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9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4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639286755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9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4/1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468942722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9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5/1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725958407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5/1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808385965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5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3023321214"/>
                  </a:ext>
                </a:extLst>
              </a:tr>
              <a:tr h="15093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5/2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571" marR="4571" marT="4571" marB="0" anchor="ctr"/>
                </a:tc>
                <a:extLst>
                  <a:ext uri="{0D108BD9-81ED-4DB2-BD59-A6C34878D82A}">
                    <a16:rowId xmlns:a16="http://schemas.microsoft.com/office/drawing/2014/main" val="1789606678"/>
                  </a:ext>
                </a:extLst>
              </a:tr>
            </a:tbl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81A3B408-2052-DA35-D696-9D541A842B54}"/>
              </a:ext>
            </a:extLst>
          </p:cNvPr>
          <p:cNvSpPr txBox="1"/>
          <p:nvPr/>
        </p:nvSpPr>
        <p:spPr>
          <a:xfrm>
            <a:off x="85452" y="0"/>
            <a:ext cx="87782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Bank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umber and sampling date.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585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2B70D21-AA93-3678-9A3B-3F8050FC92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2713630"/>
              </p:ext>
            </p:extLst>
          </p:nvPr>
        </p:nvGraphicFramePr>
        <p:xfrm>
          <a:off x="1404183" y="108022"/>
          <a:ext cx="3635648" cy="67390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33818">
                  <a:extLst>
                    <a:ext uri="{9D8B030D-6E8A-4147-A177-3AD203B41FA5}">
                      <a16:colId xmlns:a16="http://schemas.microsoft.com/office/drawing/2014/main" val="1417623503"/>
                    </a:ext>
                  </a:extLst>
                </a:gridCol>
                <a:gridCol w="1200915">
                  <a:extLst>
                    <a:ext uri="{9D8B030D-6E8A-4147-A177-3AD203B41FA5}">
                      <a16:colId xmlns:a16="http://schemas.microsoft.com/office/drawing/2014/main" val="1825272515"/>
                    </a:ext>
                  </a:extLst>
                </a:gridCol>
                <a:gridCol w="1200915">
                  <a:extLst>
                    <a:ext uri="{9D8B030D-6E8A-4147-A177-3AD203B41FA5}">
                      <a16:colId xmlns:a16="http://schemas.microsoft.com/office/drawing/2014/main" val="86388133"/>
                    </a:ext>
                  </a:extLst>
                </a:gridCol>
              </a:tblGrid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5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419659388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173659422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9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627417748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210309722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242173620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260540864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580340623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0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340148482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17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7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755606269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1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8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4052632748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1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8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82946916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2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8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93379103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3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9/1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860887660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3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9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94954891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3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0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307581997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3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0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36717378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3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1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79831529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4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1/1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890428436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4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1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908838368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4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2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070177863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4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2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968992624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SF14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996720287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SF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2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82834512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SF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3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744827094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SF1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3/1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304630007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SF1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1915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4/1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472143373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777387159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425874929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264719231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84619706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4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511744153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9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4/1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526305036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1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4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206782680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1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5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766734103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1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026651387"/>
                  </a:ext>
                </a:extLst>
              </a:tr>
              <a:tr h="15336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1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40246377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45677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860CFA-9602-B427-6FFF-A8D14934180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36AA5B4C-157C-44DF-987C-097328D0A6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5631194"/>
              </p:ext>
            </p:extLst>
          </p:nvPr>
        </p:nvGraphicFramePr>
        <p:xfrm>
          <a:off x="1404259" y="32658"/>
          <a:ext cx="3667470" cy="6556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4616">
                  <a:extLst>
                    <a:ext uri="{9D8B030D-6E8A-4147-A177-3AD203B41FA5}">
                      <a16:colId xmlns:a16="http://schemas.microsoft.com/office/drawing/2014/main" val="3461051247"/>
                    </a:ext>
                  </a:extLst>
                </a:gridCol>
                <a:gridCol w="1211427">
                  <a:extLst>
                    <a:ext uri="{9D8B030D-6E8A-4147-A177-3AD203B41FA5}">
                      <a16:colId xmlns:a16="http://schemas.microsoft.com/office/drawing/2014/main" val="309647380"/>
                    </a:ext>
                  </a:extLst>
                </a:gridCol>
                <a:gridCol w="1211427">
                  <a:extLst>
                    <a:ext uri="{9D8B030D-6E8A-4147-A177-3AD203B41FA5}">
                      <a16:colId xmlns:a16="http://schemas.microsoft.com/office/drawing/2014/main" val="2078803511"/>
                    </a:ext>
                  </a:extLst>
                </a:gridCol>
              </a:tblGrid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91707606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326181446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888751348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1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91716330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02300058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915800576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6007370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015039732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099754610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99186456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39564158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4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9/1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589663840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4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10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78532748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5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12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423749907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5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12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00405984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5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12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59919340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799894900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804823223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467775834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248760340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548694698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1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151959963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1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178080358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652038322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370945201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051791588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710991884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25877213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1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3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62304216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2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3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943220670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2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3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56713905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2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3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476246442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2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3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733048046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2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685089875"/>
                  </a:ext>
                </a:extLst>
              </a:tr>
              <a:tr h="1518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4840812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914760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2CD5FE-588E-7341-4809-A5B5CCFBA32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709D4AA0-A865-6A29-9F5F-B8D9AEFEF37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91292049"/>
              </p:ext>
            </p:extLst>
          </p:nvPr>
        </p:nvGraphicFramePr>
        <p:xfrm>
          <a:off x="1445583" y="127591"/>
          <a:ext cx="3689943" cy="66533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2241">
                  <a:extLst>
                    <a:ext uri="{9D8B030D-6E8A-4147-A177-3AD203B41FA5}">
                      <a16:colId xmlns:a16="http://schemas.microsoft.com/office/drawing/2014/main" val="1986645362"/>
                    </a:ext>
                  </a:extLst>
                </a:gridCol>
                <a:gridCol w="1218851">
                  <a:extLst>
                    <a:ext uri="{9D8B030D-6E8A-4147-A177-3AD203B41FA5}">
                      <a16:colId xmlns:a16="http://schemas.microsoft.com/office/drawing/2014/main" val="3637644166"/>
                    </a:ext>
                  </a:extLst>
                </a:gridCol>
                <a:gridCol w="1218851">
                  <a:extLst>
                    <a:ext uri="{9D8B030D-6E8A-4147-A177-3AD203B41FA5}">
                      <a16:colId xmlns:a16="http://schemas.microsoft.com/office/drawing/2014/main" val="1671273443"/>
                    </a:ext>
                  </a:extLst>
                </a:gridCol>
              </a:tblGrid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01506163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66625914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449030878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130847089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52372396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4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93163901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4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6/1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234773490"/>
                  </a:ext>
                </a:extLst>
              </a:tr>
              <a:tr h="20309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968855707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401663537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26448223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40893103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55423671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5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561950185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6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22201286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6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952796269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6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15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35320849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6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482000419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6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728877920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9/2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92638278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252469032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3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737375842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8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1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625879270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5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6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605800817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8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85798813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9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9/19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948503054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9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9/2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917656590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0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55441718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0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3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77428424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1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1/2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749150915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1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2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111217518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1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2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074551315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2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2/1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675532438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2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2/2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298799343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2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2/2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10151696"/>
                  </a:ext>
                </a:extLst>
              </a:tr>
              <a:tr h="1897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2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2/2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072071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696747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20830CD-A249-06EC-FAF7-48099CAA0C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75286937-630E-5F5A-25A4-3638A58CDA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7742942"/>
              </p:ext>
            </p:extLst>
          </p:nvPr>
        </p:nvGraphicFramePr>
        <p:xfrm>
          <a:off x="1392865" y="106326"/>
          <a:ext cx="3710764" cy="6556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9308">
                  <a:extLst>
                    <a:ext uri="{9D8B030D-6E8A-4147-A177-3AD203B41FA5}">
                      <a16:colId xmlns:a16="http://schemas.microsoft.com/office/drawing/2014/main" val="1566434637"/>
                    </a:ext>
                  </a:extLst>
                </a:gridCol>
                <a:gridCol w="1225728">
                  <a:extLst>
                    <a:ext uri="{9D8B030D-6E8A-4147-A177-3AD203B41FA5}">
                      <a16:colId xmlns:a16="http://schemas.microsoft.com/office/drawing/2014/main" val="2315904875"/>
                    </a:ext>
                  </a:extLst>
                </a:gridCol>
                <a:gridCol w="1225728">
                  <a:extLst>
                    <a:ext uri="{9D8B030D-6E8A-4147-A177-3AD203B41FA5}">
                      <a16:colId xmlns:a16="http://schemas.microsoft.com/office/drawing/2014/main" val="2319898699"/>
                    </a:ext>
                  </a:extLst>
                </a:gridCol>
              </a:tblGrid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0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3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10633568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1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1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347842561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1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1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06699431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1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1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4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084939323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1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5/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011407223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1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5/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036833155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1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5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485944510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7/1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650771283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7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50304011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8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083057741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8/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095880770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2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8/1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5591418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3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0/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176878016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3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5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0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998496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3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7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1/1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164132565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3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2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321768693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MF3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2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2/3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628585936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MF4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3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2/1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787945902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MF4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3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3/1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14612399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MF4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3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3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797942766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MF5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3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5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59632213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MF5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3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6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076569295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6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3/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20810037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7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4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612503339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7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4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75583821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7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6/1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97291174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8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7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465420494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8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8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26039162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8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9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750982444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0MF9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/11/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862755283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337413278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7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51430308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924381307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/1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772536873"/>
                  </a:ext>
                </a:extLst>
              </a:tr>
              <a:tr h="1508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/2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507620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06852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697E88-7083-137B-5010-9600A69113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DD95F04C-040C-5A04-84A4-76F258D8538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6183680"/>
              </p:ext>
            </p:extLst>
          </p:nvPr>
        </p:nvGraphicFramePr>
        <p:xfrm>
          <a:off x="1382233" y="95693"/>
          <a:ext cx="3710761" cy="6556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59307">
                  <a:extLst>
                    <a:ext uri="{9D8B030D-6E8A-4147-A177-3AD203B41FA5}">
                      <a16:colId xmlns:a16="http://schemas.microsoft.com/office/drawing/2014/main" val="1052697141"/>
                    </a:ext>
                  </a:extLst>
                </a:gridCol>
                <a:gridCol w="1225727">
                  <a:extLst>
                    <a:ext uri="{9D8B030D-6E8A-4147-A177-3AD203B41FA5}">
                      <a16:colId xmlns:a16="http://schemas.microsoft.com/office/drawing/2014/main" val="1012244067"/>
                    </a:ext>
                  </a:extLst>
                </a:gridCol>
                <a:gridCol w="1225727">
                  <a:extLst>
                    <a:ext uri="{9D8B030D-6E8A-4147-A177-3AD203B41FA5}">
                      <a16:colId xmlns:a16="http://schemas.microsoft.com/office/drawing/2014/main" val="3713867668"/>
                    </a:ext>
                  </a:extLst>
                </a:gridCol>
              </a:tblGrid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1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4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766637529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1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4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35575407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2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6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860883469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2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6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48020126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2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7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139370258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2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7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839488289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2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9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255941561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0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31518187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1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331874400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1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321819848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2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539423645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MF3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2/1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05106865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43843517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895775976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25729893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79079925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4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738009672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1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5/1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531817268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1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2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482915671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1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584439077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1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29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014397057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1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6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20884190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2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2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732933873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2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1863127081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MF2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8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963360671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4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/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041674338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4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/1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96159236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672557042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1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920117526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4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842787116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319279833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2/2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369970759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5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3/2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25097333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2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883798754"/>
                  </a:ext>
                </a:extLst>
              </a:tr>
              <a:tr h="15208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2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1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440" marR="4440" marT="4440" marB="0" anchor="ctr"/>
                </a:tc>
                <a:extLst>
                  <a:ext uri="{0D108BD9-81ED-4DB2-BD59-A6C34878D82A}">
                    <a16:rowId xmlns:a16="http://schemas.microsoft.com/office/drawing/2014/main" val="28036261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77575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1D0679F-DF2F-E71C-6B92-14389930E0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0CA1AF3E-3FD2-0B52-3213-6A45117A091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3368592"/>
              </p:ext>
            </p:extLst>
          </p:nvPr>
        </p:nvGraphicFramePr>
        <p:xfrm>
          <a:off x="1382233" y="0"/>
          <a:ext cx="3732028" cy="67390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6526">
                  <a:extLst>
                    <a:ext uri="{9D8B030D-6E8A-4147-A177-3AD203B41FA5}">
                      <a16:colId xmlns:a16="http://schemas.microsoft.com/office/drawing/2014/main" val="2897157248"/>
                    </a:ext>
                  </a:extLst>
                </a:gridCol>
                <a:gridCol w="1232751">
                  <a:extLst>
                    <a:ext uri="{9D8B030D-6E8A-4147-A177-3AD203B41FA5}">
                      <a16:colId xmlns:a16="http://schemas.microsoft.com/office/drawing/2014/main" val="1325031412"/>
                    </a:ext>
                  </a:extLst>
                </a:gridCol>
                <a:gridCol w="1232751">
                  <a:extLst>
                    <a:ext uri="{9D8B030D-6E8A-4147-A177-3AD203B41FA5}">
                      <a16:colId xmlns:a16="http://schemas.microsoft.com/office/drawing/2014/main" val="1085674598"/>
                    </a:ext>
                  </a:extLst>
                </a:gridCol>
              </a:tblGrid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2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5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184780621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2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5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018798252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2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5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37509850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2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5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486956265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3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6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090200308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3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6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215382215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3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6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335698413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4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6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5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321820659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6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70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6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447125967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7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7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007601764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8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8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7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266475408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8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8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1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953309428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9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8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8/2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112440686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9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8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9/1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336070950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0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8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1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738869765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MF109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9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3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165452867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8SF1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5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/12/1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964767642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1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5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2/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38895610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1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5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2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350649372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1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5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3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832868152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2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5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3/1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326639396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7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6/2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903397920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7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6/2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48782558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3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7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6/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768996706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0423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0/2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4147171491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0/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848629758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1/1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372775416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19SF68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9/11/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598109062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SF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1/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621458379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4154360086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2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7/2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4287442390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1SF1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1/6/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2968723389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2SF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2/3/15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689213451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3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4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4/11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1286845055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8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34718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1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/>
                </a:tc>
                <a:extLst>
                  <a:ext uri="{0D108BD9-81ED-4DB2-BD59-A6C34878D82A}">
                    <a16:rowId xmlns:a16="http://schemas.microsoft.com/office/drawing/2014/main" val="3433228706"/>
                  </a:ext>
                </a:extLst>
              </a:tr>
              <a:tr h="1465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V23SF7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V5688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/10/2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317" marR="4317" marT="431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513263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40554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7</TotalTime>
  <Words>751</Words>
  <Application>Microsoft Office PowerPoint</Application>
  <PresentationFormat>宽屏</PresentationFormat>
  <Paragraphs>739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ie ma</dc:creator>
  <cp:lastModifiedBy>jie ma</cp:lastModifiedBy>
  <cp:revision>6</cp:revision>
  <dcterms:created xsi:type="dcterms:W3CDTF">2025-04-28T08:25:04Z</dcterms:created>
  <dcterms:modified xsi:type="dcterms:W3CDTF">2025-05-07T00:48:51Z</dcterms:modified>
</cp:coreProperties>
</file>